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C2D881-CCB0-4749-A369-AB88B352E50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5EAF0C-5A4E-474C-AFAB-0790C3FDAE2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F57651-7F7B-4BB0-84DE-4F4BD86A138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36AA64-4D25-4ADD-AE7E-F23A0838D2D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E5C887-EC17-4BF2-AF0F-41D7323C437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B4C4B0-8CFD-473F-BDC0-7E5B53B39C4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3379D7-9D70-4E00-B8DF-7D3C3E8FC3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778C42-61E5-4252-9A75-90222183A79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9F9290-B61C-46B4-8668-C936692111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66CB2A-003A-4810-861E-055C536FC7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1F3378-22D1-4E1B-8850-E60CBA25EB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C4AB20-6609-4A50-B8AE-AAACA4A553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F9C83BD-7715-475F-B9F4-0CF149FCDA1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png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png"/><Relationship Id="rId13" Type="http://schemas.openxmlformats.org/officeDocument/2006/relationships/slideLayout" Target="../slideLayouts/slideLayout1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3505320" y="1116000"/>
          <a:ext cx="3009960" cy="17510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505320" y="1116000"/>
                    <a:ext cx="3009960" cy="1751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3" name=""/>
          <p:cNvGraphicFramePr/>
          <p:nvPr/>
        </p:nvGraphicFramePr>
        <p:xfrm>
          <a:off x="419040" y="1116000"/>
          <a:ext cx="3009960" cy="175104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4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419040" y="1116000"/>
                    <a:ext cx="3009960" cy="1751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5" name=""/>
          <p:cNvGraphicFramePr/>
          <p:nvPr/>
        </p:nvGraphicFramePr>
        <p:xfrm>
          <a:off x="419040" y="2916360"/>
          <a:ext cx="3009960" cy="174312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46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419040" y="2916360"/>
                    <a:ext cx="3009960" cy="1743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7" name=""/>
          <p:cNvGraphicFramePr/>
          <p:nvPr/>
        </p:nvGraphicFramePr>
        <p:xfrm>
          <a:off x="3505320" y="2916360"/>
          <a:ext cx="3009960" cy="174600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48" name="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3505320" y="2916360"/>
                    <a:ext cx="3009960" cy="1746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9" name=""/>
          <p:cNvGraphicFramePr/>
          <p:nvPr/>
        </p:nvGraphicFramePr>
        <p:xfrm>
          <a:off x="404640" y="4788000"/>
          <a:ext cx="3024360" cy="175104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50" name="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404640" y="4788000"/>
                    <a:ext cx="3024360" cy="1751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1" name=""/>
          <p:cNvGraphicFramePr/>
          <p:nvPr/>
        </p:nvGraphicFramePr>
        <p:xfrm>
          <a:off x="3500280" y="4788000"/>
          <a:ext cx="3024360" cy="175716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52" name="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3500280" y="4788000"/>
                    <a:ext cx="3024360" cy="1757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3" name=""/>
          <p:cNvSpPr/>
          <p:nvPr/>
        </p:nvSpPr>
        <p:spPr>
          <a:xfrm>
            <a:off x="1844640" y="6588000"/>
            <a:ext cx="144360" cy="144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2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3324240" y="6588000"/>
            <a:ext cx="144360" cy="144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4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352440" y="6588000"/>
            <a:ext cx="144360" cy="144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60280" y="5605560"/>
            <a:ext cx="144360" cy="144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60280" y="4775040"/>
            <a:ext cx="144360" cy="144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260280" y="3727440"/>
            <a:ext cx="144360" cy="144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260280" y="2914560"/>
            <a:ext cx="144360" cy="144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260280" y="1933560"/>
            <a:ext cx="144360" cy="144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260280" y="1116000"/>
            <a:ext cx="144360" cy="144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4940280" y="6588000"/>
            <a:ext cx="144360" cy="144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2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6427800" y="6588000"/>
            <a:ext cx="144360" cy="144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4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628640" y="6877080"/>
            <a:ext cx="648000" cy="142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ime (hr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 rot="16200000">
            <a:off x="-99720" y="5579640"/>
            <a:ext cx="576360" cy="144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ell Inde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 rot="16200000">
            <a:off x="-99720" y="3708000"/>
            <a:ext cx="576360" cy="144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ell Inde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 rot="16200000">
            <a:off x="-99720" y="1908000"/>
            <a:ext cx="576000" cy="144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ell Inde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4726080" y="6877080"/>
            <a:ext cx="647640" cy="142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ime (hr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836640" y="1187280"/>
            <a:ext cx="863640" cy="505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trl CAF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trl-peptid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GD-peptid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3933720" y="1187280"/>
            <a:ext cx="1081080" cy="36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trl CAF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nti-(Integrin-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836640" y="2987640"/>
            <a:ext cx="1079640" cy="36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trl CAF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nti-(Integrin-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3933720" y="2987640"/>
            <a:ext cx="1079640" cy="36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trl CAF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nti-(Integrin-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836640" y="4859280"/>
            <a:ext cx="1079640" cy="36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trl CAF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8 G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3933720" y="4788000"/>
            <a:ext cx="1150920" cy="10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trl CAF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8 G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GD-peptid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nti-(Integrin-</a:t>
            </a:r>
            <a:r>
              <a:rPr b="0" lang="el-GR" sz="9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nti-(Integrin-</a:t>
            </a:r>
            <a:r>
              <a:rPr b="0" lang="el-GR" sz="9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2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nti-(Integrin-</a:t>
            </a:r>
            <a:r>
              <a:rPr b="0" lang="el-GR" sz="9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5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549360" y="1585800"/>
            <a:ext cx="2872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549360" y="1428840"/>
            <a:ext cx="287280" cy="0"/>
          </a:xfrm>
          <a:prstGeom prst="line">
            <a:avLst/>
          </a:prstGeom>
          <a:ln w="28440">
            <a:solidFill>
              <a:srgbClr val="00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549360" y="1273320"/>
            <a:ext cx="287280" cy="0"/>
          </a:xfrm>
          <a:prstGeom prst="line">
            <a:avLst/>
          </a:prstGeom>
          <a:ln w="28440">
            <a:solidFill>
              <a:srgbClr val="99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3646440" y="1441440"/>
            <a:ext cx="2872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3646440" y="1306440"/>
            <a:ext cx="287280" cy="0"/>
          </a:xfrm>
          <a:prstGeom prst="line">
            <a:avLst/>
          </a:prstGeom>
          <a:ln w="28440">
            <a:solidFill>
              <a:srgbClr val="99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3645000" y="3238560"/>
            <a:ext cx="2872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3645000" y="3090960"/>
            <a:ext cx="287280" cy="0"/>
          </a:xfrm>
          <a:prstGeom prst="line">
            <a:avLst/>
          </a:prstGeom>
          <a:ln w="28440">
            <a:solidFill>
              <a:srgbClr val="99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549360" y="3251160"/>
            <a:ext cx="2872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549360" y="3103560"/>
            <a:ext cx="287280" cy="0"/>
          </a:xfrm>
          <a:prstGeom prst="line">
            <a:avLst/>
          </a:prstGeom>
          <a:ln w="28440">
            <a:solidFill>
              <a:srgbClr val="99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549360" y="5130720"/>
            <a:ext cx="2872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549360" y="4971960"/>
            <a:ext cx="287280" cy="0"/>
          </a:xfrm>
          <a:prstGeom prst="line">
            <a:avLst/>
          </a:prstGeom>
          <a:ln w="28440">
            <a:solidFill>
              <a:srgbClr val="99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3646440" y="5076720"/>
            <a:ext cx="2872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3646440" y="5219640"/>
            <a:ext cx="287280" cy="0"/>
          </a:xfrm>
          <a:prstGeom prst="line">
            <a:avLst/>
          </a:prstGeom>
          <a:ln w="28440">
            <a:solidFill>
              <a:srgbClr val="00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3646440" y="4906800"/>
            <a:ext cx="287280" cy="0"/>
          </a:xfrm>
          <a:prstGeom prst="line">
            <a:avLst/>
          </a:prstGeom>
          <a:ln w="28440">
            <a:solidFill>
              <a:srgbClr val="99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3645000" y="5364000"/>
            <a:ext cx="287280" cy="0"/>
          </a:xfrm>
          <a:prstGeom prst="line">
            <a:avLst/>
          </a:prstGeom>
          <a:ln w="2844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3645000" y="5508720"/>
            <a:ext cx="287280" cy="0"/>
          </a:xfrm>
          <a:prstGeom prst="line">
            <a:avLst/>
          </a:prstGeom>
          <a:ln w="2844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3645000" y="5653080"/>
            <a:ext cx="287280" cy="0"/>
          </a:xfrm>
          <a:prstGeom prst="line">
            <a:avLst/>
          </a:prstGeom>
          <a:ln w="284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3500280" y="6588000"/>
            <a:ext cx="144720" cy="144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2490120" y="8101080"/>
            <a:ext cx="1390680" cy="307080"/>
          </a:xfrm>
          <a:prstGeom prst="rect">
            <a:avLst/>
          </a:prstGeom>
          <a:solidFill>
            <a:srgbClr val="ddddd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uppl. Figure 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25T14:28:24Z</dcterms:created>
  <dc:creator>the2702unn</dc:creator>
  <dc:description/>
  <dc:language>en-US</dc:language>
  <cp:lastModifiedBy>the2702unn</cp:lastModifiedBy>
  <dcterms:modified xsi:type="dcterms:W3CDTF">2012-02-25T14:29:45Z</dcterms:modified>
  <cp:revision>1</cp:revision>
  <dc:subject/>
  <dc:title>Lysbilde 1</dc:title>
</cp:coreProperties>
</file>